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0" d="100"/>
          <a:sy n="70" d="100"/>
        </p:scale>
        <p:origin x="-112" y="-28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9660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726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932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6656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138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5254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300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473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769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39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208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5BDD69-AF6D-1241-B535-215C4EB21E1A}" type="datetimeFigureOut">
              <a:t>3/10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CF6C9C-0243-CC43-AC23-C57C3C21396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4234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0030125"/>
              </p:ext>
            </p:extLst>
          </p:nvPr>
        </p:nvGraphicFramePr>
        <p:xfrm>
          <a:off x="1303901" y="1292417"/>
          <a:ext cx="6536197" cy="4525975"/>
        </p:xfrm>
        <a:graphic>
          <a:graphicData uri="http://schemas.openxmlformats.org/drawingml/2006/table">
            <a:tbl>
              <a:tblPr/>
              <a:tblGrid>
                <a:gridCol w="764124"/>
                <a:gridCol w="646566"/>
                <a:gridCol w="858170"/>
                <a:gridCol w="587787"/>
                <a:gridCol w="623055"/>
                <a:gridCol w="529009"/>
                <a:gridCol w="517253"/>
                <a:gridCol w="529009"/>
                <a:gridCol w="505497"/>
                <a:gridCol w="975727"/>
              </a:tblGrid>
              <a:tr h="1810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 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G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81039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it-IT" sz="11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c12</a:t>
                      </a:r>
                      <a:r>
                        <a:rPr lang="it-IT" sz="1100" b="1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endParaRPr lang="it-IT" sz="1100" b="1" i="1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1756" marR="11756" marT="1175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9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/23</a:t>
                      </a:r>
                      <a:r>
                        <a:rPr lang="bg-BG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/37</a:t>
                      </a:r>
                      <a:r>
                        <a:rPr lang="bg-BG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gridSpan="10">
                  <a:txBody>
                    <a:bodyPr/>
                    <a:lstStyle/>
                    <a:p>
                      <a:pPr algn="ctr" fontAlgn="b"/>
                      <a:r>
                        <a:rPr lang="sk-SK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103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up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me 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eriment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ND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NA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EL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NB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UD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LG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otal cells (n)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181039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it-IT" sz="1100" b="1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dc12-6</a:t>
                      </a:r>
                    </a:p>
                  </a:txBody>
                  <a:tcPr marL="11756" marR="11756" marT="11756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9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/23</a:t>
                      </a:r>
                      <a:r>
                        <a:rPr lang="bg-BG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4/37</a:t>
                      </a:r>
                      <a:r>
                        <a:rPr lang="bg-BG" sz="11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</a:t>
                      </a:r>
                      <a:r>
                        <a:rPr lang="bg-BG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8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1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103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sk-S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xpt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3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2</a:t>
                      </a:r>
                    </a:p>
                  </a:txBody>
                  <a:tcPr marL="11756" marR="11756" marT="11756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217593" y="980447"/>
            <a:ext cx="41712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S6 Table Data summary table for figure 4D  </a:t>
            </a:r>
            <a:endParaRPr lang="en-US" sz="1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243363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99</Words>
  <Application>Microsoft Macintosh PowerPoint</Application>
  <PresentationFormat>On-screen Show (4:3)</PresentationFormat>
  <Paragraphs>19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ase Wester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 Tartakoff</dc:creator>
  <cp:lastModifiedBy>Alan Tartakoff</cp:lastModifiedBy>
  <cp:revision>2</cp:revision>
  <dcterms:created xsi:type="dcterms:W3CDTF">2017-03-10T17:55:11Z</dcterms:created>
  <dcterms:modified xsi:type="dcterms:W3CDTF">2017-03-10T17:58:16Z</dcterms:modified>
</cp:coreProperties>
</file>